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3" autoAdjust="0"/>
    <p:restoredTop sz="94660"/>
  </p:normalViewPr>
  <p:slideViewPr>
    <p:cSldViewPr snapToGrid="0">
      <p:cViewPr varScale="1">
        <p:scale>
          <a:sx n="68" d="100"/>
          <a:sy n="68" d="100"/>
        </p:scale>
        <p:origin x="254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627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27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239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545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157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111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2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010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330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463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845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882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443490" y="838200"/>
            <a:ext cx="3236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674998" y="2514600"/>
            <a:ext cx="3236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105400" y="838200"/>
            <a:ext cx="278143" cy="2754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5" name="Object 14"/>
          <p:cNvGraphicFramePr>
            <a:graphicFrameLocks noChangeAspect="1"/>
          </p:cNvGraphicFramePr>
          <p:nvPr>
            <p:extLst/>
          </p:nvPr>
        </p:nvGraphicFramePr>
        <p:xfrm>
          <a:off x="5257800" y="1035050"/>
          <a:ext cx="1123950" cy="1784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6" name="SPW 12.0 Graph" r:id="rId3" imgW="2249471" imgH="3566136" progId="SigmaPlotGraphicObject.11">
                  <p:embed/>
                </p:oleObj>
              </mc:Choice>
              <mc:Fallback>
                <p:oleObj name="SPW 12.0 Graph" r:id="rId3" imgW="2249471" imgH="3566136" progId="SigmaPlotGraphicObject.11">
                  <p:embed/>
                  <p:pic>
                    <p:nvPicPr>
                      <p:cNvPr id="15" name="Object 1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57800" y="1035050"/>
                        <a:ext cx="1123950" cy="17843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609600" y="2743200"/>
          <a:ext cx="1789113" cy="1536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7" name="SPW 12.0 Graph" r:id="rId5" imgW="3576767" imgH="3073882" progId="SigmaPlotGraphicObject.11">
                  <p:embed/>
                </p:oleObj>
              </mc:Choice>
              <mc:Fallback>
                <p:oleObj name="SPW 12.0 Graph" r:id="rId5" imgW="3576767" imgH="3073882" progId="SigmaPlotGraphicObject.11">
                  <p:embed/>
                  <p:pic>
                    <p:nvPicPr>
                      <p:cNvPr id="4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09600" y="2743200"/>
                        <a:ext cx="1789113" cy="15367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2590800" y="2743200"/>
          <a:ext cx="1782763" cy="1538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8" name="SPW 12.0 Graph" r:id="rId7" imgW="3564491" imgH="3075324" progId="SigmaPlotGraphicObject.11">
                  <p:embed/>
                </p:oleObj>
              </mc:Choice>
              <mc:Fallback>
                <p:oleObj name="SPW 12.0 Graph" r:id="rId7" imgW="3564491" imgH="3075324" progId="SigmaPlotGraphicObject.11">
                  <p:embed/>
                  <p:pic>
                    <p:nvPicPr>
                      <p:cNvPr id="5" name="Objec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90800" y="2743200"/>
                        <a:ext cx="1782763" cy="15382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/>
          </p:nvPr>
        </p:nvGraphicFramePr>
        <p:xfrm>
          <a:off x="2202684" y="1133856"/>
          <a:ext cx="1512526" cy="14158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9" name="SPW 12.0 Graph" r:id="rId9" imgW="3025051" imgH="2831719" progId="SigmaPlotGraphicObject.11">
                  <p:embed/>
                </p:oleObj>
              </mc:Choice>
              <mc:Fallback>
                <p:oleObj name="SPW 12.0 Graph" r:id="rId9" imgW="3025051" imgH="2831719" progId="SigmaPlotGraphicObject.11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202684" y="1133856"/>
                        <a:ext cx="1512526" cy="14158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/>
          </p:nvPr>
        </p:nvGraphicFramePr>
        <p:xfrm>
          <a:off x="3810000" y="1042416"/>
          <a:ext cx="1418828" cy="15057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0" name="SPW 12.0 Graph" r:id="rId11" imgW="2837655" imgH="3011540" progId="SigmaPlotGraphicObject.11">
                  <p:embed/>
                </p:oleObj>
              </mc:Choice>
              <mc:Fallback>
                <p:oleObj name="SPW 12.0 Graph" r:id="rId11" imgW="2837655" imgH="3011540" progId="SigmaPlotGraphicObject.11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810000" y="1042416"/>
                        <a:ext cx="1418828" cy="15057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/>
          </p:nvPr>
        </p:nvGraphicFramePr>
        <p:xfrm>
          <a:off x="586248" y="1131484"/>
          <a:ext cx="1501874" cy="16117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1" name="SPW 12.0 Graph" r:id="rId13" imgW="3003748" imgH="3223432" progId="SigmaPlotGraphicObject.11">
                  <p:embed/>
                </p:oleObj>
              </mc:Choice>
              <mc:Fallback>
                <p:oleObj name="SPW 12.0 Graph" r:id="rId13" imgW="3003748" imgH="3223432" progId="SigmaPlotGraphicObject.11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86248" y="1131484"/>
                        <a:ext cx="1501874" cy="16117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443490" y="2514600"/>
            <a:ext cx="3236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DAF9860-B493-4FEB-8590-86A11E1B4261}"/>
              </a:ext>
            </a:extLst>
          </p:cNvPr>
          <p:cNvSpPr/>
          <p:nvPr/>
        </p:nvSpPr>
        <p:spPr>
          <a:xfrm>
            <a:off x="767106" y="4659740"/>
            <a:ext cx="5191608" cy="37673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3 Fig  EcoHIV integration frequency in mice resembles that of HIV in PBMC of patients on long-term ART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 panels left to right total HIV DNA was measured by QPCR, integrated DNA was measured with nested QPCR, and genomic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vRN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measured by QPCR in PBMC from HIV patients with average CD4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 cell counts more than 500/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 blood.  The line represents the mean value.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e ratio of integrated to total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vDN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or each patient sample or each mouse sample more than 2 months after infection (Fig. 2A) and then the mean ratios of groups were obtained.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.D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t 6 weeks after EcoHIV infection, mice were treated with vehicle or abacavir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altegravi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or 14 days prior to tissue collection.  Integrated EcoHIV DNA was measured in spleen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r PC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e horizontal bar represents the median of these values.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14830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69</Words>
  <Application>Microsoft Office PowerPoint</Application>
  <PresentationFormat>Letter Paper (8.5x11 in)</PresentationFormat>
  <Paragraphs>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SPW 12.0 Graph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Volsky</dc:creator>
  <cp:lastModifiedBy>David Volsky</cp:lastModifiedBy>
  <cp:revision>5</cp:revision>
  <dcterms:created xsi:type="dcterms:W3CDTF">2018-05-11T18:35:20Z</dcterms:created>
  <dcterms:modified xsi:type="dcterms:W3CDTF">2018-05-14T19:23:27Z</dcterms:modified>
</cp:coreProperties>
</file>